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35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CF043D-9BA8-702C-0C05-4935A0383E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F4E5FE4-B4B6-09A8-DA75-1C7558CDDE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6877B5-CED8-E346-A99E-F941E03F5C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D012B-07FB-4BD0-B7F1-48549ACE5987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4567CF3-4431-F478-50E2-823638D39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2A6D52D-0364-64D3-7949-EC34E599CB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F0C72-BC23-4984-B023-034B7A86E6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2462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AB1DEB-B344-207E-CF95-FA9C3B4EE7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342BD4D-259F-05D8-3CAD-F44421430C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E4EFB2-CA3F-7D59-58E8-F5E9EB8D2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D012B-07FB-4BD0-B7F1-48549ACE5987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E55D8A-009E-3CBD-7F54-EE0583EFA2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D167284-BA93-CA88-D454-7CB750B1B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F0C72-BC23-4984-B023-034B7A86E6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5913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B9615F4-280A-5368-78E8-501BD0DF72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C50E64C-457C-F575-320F-B1D4C79391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805B781-3256-DB7A-CDC9-F555556571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D012B-07FB-4BD0-B7F1-48549ACE5987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DF3D207-8087-7B4D-1067-E539AF104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DBD161-C0D0-96EE-9EF6-56B2625C1E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F0C72-BC23-4984-B023-034B7A86E6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7356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67E685-69C9-5E4C-5899-A862CABC02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075D09E-41D5-A7E9-5FE2-D200B88823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58CD71-FA12-3AA1-CD03-F0E1A7890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D012B-07FB-4BD0-B7F1-48549ACE5987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2028FD-3159-16EF-71FD-3732B0EDE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67DE47-975E-D258-A0E9-36D81CDBD1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F0C72-BC23-4984-B023-034B7A86E6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7663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9F3A99-2423-E638-DB4A-62C143D990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7840E35-5925-AC04-C332-52E02603A8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C98C7BC-D49D-C362-3799-DA8E351F5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D012B-07FB-4BD0-B7F1-48549ACE5987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0239FC1-086C-7A21-FAB2-90621E4E80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7FEFA48-6FA5-4F1E-A74C-D3E108ECF0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F0C72-BC23-4984-B023-034B7A86E6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0942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27E6B1-F244-1844-3B6C-0FFF2FD9D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B5CB082-37AE-F016-1605-D59418AE50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7EE3177-B069-6073-53F3-5250E8245F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143BEBF-7E6F-8D9C-6A7B-4E0001A1F8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D012B-07FB-4BD0-B7F1-48549ACE5987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E2A98B6-64FA-52B6-E43E-0BBD0F8A83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2768884-5649-8DF7-3A4D-3FB9016259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F0C72-BC23-4984-B023-034B7A86E6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074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E1B320-CB8F-6A25-037E-A8C3854E1E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4287572-86B2-3936-B109-1F1069D679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8FB8E19-CE0D-1865-7836-D50119B2C0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7B9B305-E73D-0DEE-599F-E0E2AA3563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959FC36-B25B-BF67-64A2-26D72DA8C8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7408244-E316-3F77-22C1-9EE8C37B7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D012B-07FB-4BD0-B7F1-48549ACE5987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DC74F93-0163-4B57-961A-1B723B7182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1D6180E-2270-7E58-4930-22C5BEFD81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F0C72-BC23-4984-B023-034B7A86E6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92428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8796B4-E17F-9906-4215-D9E2DEBA3D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69DA562-04D7-0A78-265C-631FF32A0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D012B-07FB-4BD0-B7F1-48549ACE5987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CF64CAE-13A7-C86D-1F80-7A8BD08BB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30417A7-5D47-102B-735E-7CD4C4FFB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F0C72-BC23-4984-B023-034B7A86E6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2880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D86421A-DC2B-03A0-208A-880781B32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D012B-07FB-4BD0-B7F1-48549ACE5987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0742DB8-E1AF-EA09-C550-CF0E13AD4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345300E-8FAC-3CF2-12BA-EDF55F13F0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F0C72-BC23-4984-B023-034B7A86E6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9167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A8F782-9853-5EE4-DF9B-336077C0B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6A5F843-34E7-4562-568C-6149EBD783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4C55F8F-17B1-A800-7F50-7674777DBE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54473B7-E26D-D559-AB68-31FEEB7E7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D012B-07FB-4BD0-B7F1-48549ACE5987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9126061-6516-0873-3944-C1C856A364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6187204-75FB-E542-5DE2-7624774CF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F0C72-BC23-4984-B023-034B7A86E6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2908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A7E81A-B2FD-0D14-CBFA-997631DA60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8A65B75-265E-B55F-B6F6-ECC926E4BB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B37315C-9224-F3F1-8C3F-D291625A3D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7ADB648-496A-DD9D-3FF8-B965CB84A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D012B-07FB-4BD0-B7F1-48549ACE5987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A680F1B-5410-3F3B-C3CA-613CEB4D6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BBC0A30-4C72-0D81-2962-25DB3A6A62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F0C72-BC23-4984-B023-034B7A86E6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8169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ECF9764-8277-9F79-A4C9-0B86BB52E1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B710E6-6792-830B-E1D3-6BBE58ECD5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52FFCA-1A8D-AA8B-29BD-C4D4ED0143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BD012B-07FB-4BD0-B7F1-48549ACE5987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34A5F0-E36F-8D39-C009-57B0C06316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A0644FB-29CB-B6DD-85F8-A9DBB5B8CE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AF0C72-BC23-4984-B023-034B7A86E6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0677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示, 示意图&#10;&#10;描述已自动生成">
            <a:extLst>
              <a:ext uri="{FF2B5EF4-FFF2-40B4-BE49-F238E27FC236}">
                <a16:creationId xmlns:a16="http://schemas.microsoft.com/office/drawing/2014/main" id="{E9CD06B2-644E-827D-3D2F-6954241C0C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1092" y="497840"/>
            <a:ext cx="8364428" cy="1851348"/>
          </a:xfrm>
          <a:prstGeom prst="rect">
            <a:avLst/>
          </a:prstGeom>
        </p:spPr>
      </p:pic>
      <p:pic>
        <p:nvPicPr>
          <p:cNvPr id="7" name="图片 6" descr="图示, 示意图&#10;&#10;描述已自动生成">
            <a:extLst>
              <a:ext uri="{FF2B5EF4-FFF2-40B4-BE49-F238E27FC236}">
                <a16:creationId xmlns:a16="http://schemas.microsoft.com/office/drawing/2014/main" id="{36DEDE2F-17F2-4B08-B778-41AFCDED0A3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2852" y="3428999"/>
            <a:ext cx="8252668" cy="1817859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26EF664F-28CF-03FF-CCFF-D6D321091B37}"/>
              </a:ext>
            </a:extLst>
          </p:cNvPr>
          <p:cNvSpPr txBox="1"/>
          <p:nvPr/>
        </p:nvSpPr>
        <p:spPr>
          <a:xfrm>
            <a:off x="1622852" y="2479040"/>
            <a:ext cx="8526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All BALF flow graphs follow the above gating strategy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E4E7B43-0466-C993-724E-8F89C16F1147}"/>
              </a:ext>
            </a:extLst>
          </p:cNvPr>
          <p:cNvSpPr txBox="1"/>
          <p:nvPr/>
        </p:nvSpPr>
        <p:spPr>
          <a:xfrm>
            <a:off x="1794294" y="5426015"/>
            <a:ext cx="6383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ll lung flow graphs follow the above gating strategy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EA472E2-06D3-92DB-79FE-1CDFCDB166F5}"/>
              </a:ext>
            </a:extLst>
          </p:cNvPr>
          <p:cNvSpPr txBox="1"/>
          <p:nvPr/>
        </p:nvSpPr>
        <p:spPr>
          <a:xfrm rot="10800000">
            <a:off x="953067" y="655608"/>
            <a:ext cx="461665" cy="119907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BALF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A99D2DE-C5EF-31B9-88F3-B1D9D1649C1C}"/>
              </a:ext>
            </a:extLst>
          </p:cNvPr>
          <p:cNvSpPr txBox="1"/>
          <p:nvPr/>
        </p:nvSpPr>
        <p:spPr>
          <a:xfrm rot="10800000">
            <a:off x="953066" y="3657600"/>
            <a:ext cx="461665" cy="80225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dirty="0"/>
              <a:t>Lung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56247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0</Words>
  <Application>Microsoft Office PowerPoint</Application>
  <PresentationFormat>宽屏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SUS</dc:creator>
  <cp:lastModifiedBy>ASUS</cp:lastModifiedBy>
  <cp:revision>1</cp:revision>
  <dcterms:created xsi:type="dcterms:W3CDTF">2023-10-17T00:53:42Z</dcterms:created>
  <dcterms:modified xsi:type="dcterms:W3CDTF">2023-10-17T00:58:38Z</dcterms:modified>
</cp:coreProperties>
</file>